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9C3A2-9FE8-4606-81A4-ADBDAF9796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2C4D9-14A7-4D5E-A030-2C1CF7D8A0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22892-7FE0-4C8D-BAD2-5BDF9A23A9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EA52B-0DB4-45EB-BE36-2F545791C2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8B682-9BEF-4DFA-A706-123F522293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3CC600-E6E1-4990-AF6B-5345D1ECF3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B9315-85A6-48F0-B58B-F34DBEB8C3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68922-C1A2-4D4E-B01B-6B39DEAD5E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AB963-8B64-4AEE-94DD-42CF0CFD42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9832E-9E93-4B03-97FB-0547353961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93D74-9561-4170-8A48-8207E736F1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9E05E-23AC-47AA-A151-356A457BF7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7CCE58-19D3-487C-8648-1412ED746A1E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25C95D-95DC-4825-8AA6-F7EC8BE3C9A7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en 13"/>
          <p:cNvGrpSpPr/>
          <p:nvPr/>
        </p:nvGrpSpPr>
        <p:grpSpPr>
          <a:xfrm>
            <a:off x="3943440" y="2300400"/>
            <a:ext cx="1059840" cy="1198440"/>
            <a:chOff x="3943440" y="2300400"/>
            <a:chExt cx="1059840" cy="1198440"/>
          </a:xfrm>
        </p:grpSpPr>
        <p:pic>
          <p:nvPicPr>
            <p:cNvPr id="42" name="Grafik 6" descr=""/>
            <p:cNvPicPr/>
            <p:nvPr/>
          </p:nvPicPr>
          <p:blipFill>
            <a:blip r:embed="rId1"/>
            <a:srcRect l="11160" t="39285" r="78921" b="11511"/>
            <a:stretch/>
          </p:blipFill>
          <p:spPr>
            <a:xfrm>
              <a:off x="3943440" y="2300400"/>
              <a:ext cx="326880" cy="1195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"/>
            <p:cNvPicPr/>
            <p:nvPr/>
          </p:nvPicPr>
          <p:blipFill>
            <a:blip r:embed="rId2"/>
            <a:srcRect l="30423" t="33967" r="63282" b="39169"/>
            <a:stretch/>
          </p:blipFill>
          <p:spPr>
            <a:xfrm flipH="1">
              <a:off x="4267800" y="2300400"/>
              <a:ext cx="351360" cy="1198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4" descr=""/>
            <p:cNvPicPr/>
            <p:nvPr/>
          </p:nvPicPr>
          <p:blipFill>
            <a:blip r:embed="rId3"/>
            <a:srcRect l="16517" t="34053" r="74260" b="39738"/>
            <a:stretch/>
          </p:blipFill>
          <p:spPr>
            <a:xfrm flipH="1">
              <a:off x="4594680" y="2300400"/>
              <a:ext cx="408600" cy="11984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5" name="Text Box 14"/>
          <p:cNvSpPr/>
          <p:nvPr/>
        </p:nvSpPr>
        <p:spPr>
          <a:xfrm>
            <a:off x="685800" y="3995640"/>
            <a:ext cx="769608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Additional file 3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inding analysis of RASSF2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ARAH and MST1 in co-precipitation. Plasmids, that express the indicated GST-Flag-tagged-constructs (-GF) and Flag-tagged-constructs (-F) were transfected into HEK293 cells. Deletion of SARAH domain of RASSF2 was performed according to Cooper et al. 2009. After one day, total protein was extracted and Flag-tagged proteins were precipitated with anti-Flag-agarose (F) or glutathione sepharose (G). Samples were separated on a 10% PAGE gel and blotted. The precipitated and co-precipitated proteins were determined with anti-Flag-antibodies. The sizes of a protein marker (M) are indicat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feld 13"/>
          <p:cNvSpPr/>
          <p:nvPr/>
        </p:nvSpPr>
        <p:spPr>
          <a:xfrm rot="18294000">
            <a:off x="4124520" y="1209240"/>
            <a:ext cx="173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28600" indent="-228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MST1-F (a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marL="228600" indent="-228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RASSF2</a:t>
            </a:r>
            <a:r>
              <a:rPr b="0" lang="de-DE" sz="9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SARAH-GF (b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feld 14"/>
          <p:cNvSpPr/>
          <p:nvPr/>
        </p:nvSpPr>
        <p:spPr>
          <a:xfrm>
            <a:off x="4311720" y="2066760"/>
            <a:ext cx="831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F          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hteck 33"/>
          <p:cNvSpPr/>
          <p:nvPr/>
        </p:nvSpPr>
        <p:spPr>
          <a:xfrm>
            <a:off x="3936960" y="2295360"/>
            <a:ext cx="1060560" cy="1209960"/>
          </a:xfrm>
          <a:prstGeom prst="rect">
            <a:avLst/>
          </a:pr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feld 37"/>
          <p:cNvSpPr/>
          <p:nvPr/>
        </p:nvSpPr>
        <p:spPr>
          <a:xfrm>
            <a:off x="4500720" y="2525760"/>
            <a:ext cx="193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feld 52"/>
          <p:cNvSpPr/>
          <p:nvPr/>
        </p:nvSpPr>
        <p:spPr>
          <a:xfrm>
            <a:off x="4502160" y="2698920"/>
            <a:ext cx="193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Gerade Verbindung 53"/>
          <p:cNvSpPr/>
          <p:nvPr/>
        </p:nvSpPr>
        <p:spPr>
          <a:xfrm flipV="1">
            <a:off x="4303800" y="2114640"/>
            <a:ext cx="6048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feld 11"/>
          <p:cNvSpPr/>
          <p:nvPr/>
        </p:nvSpPr>
        <p:spPr>
          <a:xfrm>
            <a:off x="3981600" y="1992240"/>
            <a:ext cx="473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feld 13"/>
          <p:cNvSpPr/>
          <p:nvPr/>
        </p:nvSpPr>
        <p:spPr>
          <a:xfrm>
            <a:off x="3549600" y="2384280"/>
            <a:ext cx="62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70 k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feld 14"/>
          <p:cNvSpPr/>
          <p:nvPr/>
        </p:nvSpPr>
        <p:spPr>
          <a:xfrm>
            <a:off x="3549600" y="269244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55 k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feld 15"/>
          <p:cNvSpPr/>
          <p:nvPr/>
        </p:nvSpPr>
        <p:spPr>
          <a:xfrm>
            <a:off x="3549600" y="3289320"/>
            <a:ext cx="62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36 k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06T12:46:18Z</dcterms:created>
  <dc:creator>Antje Maria</dc:creator>
  <dc:description/>
  <dc:language>en-US</dc:language>
  <cp:lastModifiedBy>Reinhard Dammann</cp:lastModifiedBy>
  <cp:lastPrinted>2009-12-21T12:13:00Z</cp:lastPrinted>
  <dcterms:modified xsi:type="dcterms:W3CDTF">2010-09-24T15:51:19Z</dcterms:modified>
  <cp:revision>44</cp:revision>
  <dc:subject/>
  <dc:title>Folie 1</dc:title>
</cp:coreProperties>
</file>